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8" r:id="rId4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E8F8F4B-324F-B8E5-86CA-AD3E2D50BFEB}" v="17" dt="2021-11-05T09:35:23.10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1450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iol, Arnau" userId="S::arnau.fiol@irta.cat::0e47d1b4-619a-4d81-bc24-3a60b64d2bad" providerId="AD" clId="Web-{8E8F8F4B-324F-B8E5-86CA-AD3E2D50BFEB}"/>
    <pc:docChg chg="modSld">
      <pc:chgData name="Fiol, Arnau" userId="S::arnau.fiol@irta.cat::0e47d1b4-619a-4d81-bc24-3a60b64d2bad" providerId="AD" clId="Web-{8E8F8F4B-324F-B8E5-86CA-AD3E2D50BFEB}" dt="2021-11-05T09:35:22.734" v="6" actId="20577"/>
      <pc:docMkLst>
        <pc:docMk/>
      </pc:docMkLst>
      <pc:sldChg chg="modSp">
        <pc:chgData name="Fiol, Arnau" userId="S::arnau.fiol@irta.cat::0e47d1b4-619a-4d81-bc24-3a60b64d2bad" providerId="AD" clId="Web-{8E8F8F4B-324F-B8E5-86CA-AD3E2D50BFEB}" dt="2021-11-05T09:35:22.734" v="6" actId="20577"/>
        <pc:sldMkLst>
          <pc:docMk/>
          <pc:sldMk cId="346324804" sldId="259"/>
        </pc:sldMkLst>
        <pc:spChg chg="mod">
          <ac:chgData name="Fiol, Arnau" userId="S::arnau.fiol@irta.cat::0e47d1b4-619a-4d81-bc24-3a60b64d2bad" providerId="AD" clId="Web-{8E8F8F4B-324F-B8E5-86CA-AD3E2D50BFEB}" dt="2021-11-05T09:35:22.734" v="6" actId="20577"/>
          <ac:spMkLst>
            <pc:docMk/>
            <pc:sldMk cId="346324804" sldId="259"/>
            <ac:spMk id="3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24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CuadroTexto"/>
          <p:cNvSpPr txBox="1"/>
          <p:nvPr/>
        </p:nvSpPr>
        <p:spPr>
          <a:xfrm>
            <a:off x="323528" y="44624"/>
            <a:ext cx="712879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/>
              <a:t>Additional File 4: Alignment in the </a:t>
            </a:r>
            <a:r>
              <a:rPr lang="en-US" dirty="0">
                <a:ea typeface="+mn-lt"/>
                <a:cs typeface="+mn-lt"/>
              </a:rPr>
              <a:t>‘</a:t>
            </a:r>
            <a:r>
              <a:rPr lang="en-US" dirty="0" err="1"/>
              <a:t>Sanyueli</a:t>
            </a:r>
            <a:r>
              <a:rPr lang="en-US" dirty="0">
                <a:ea typeface="+mn-lt"/>
                <a:cs typeface="+mn-lt"/>
              </a:rPr>
              <a:t>’</a:t>
            </a:r>
            <a:r>
              <a:rPr lang="en-US" dirty="0"/>
              <a:t> MYB10 region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793" y="764704"/>
            <a:ext cx="9144793" cy="54381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324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323528" y="44624"/>
            <a:ext cx="8424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4: Alignment in the Zhongli-1 MYB10 region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512" y="980728"/>
            <a:ext cx="9144793" cy="54076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82618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323528" y="44624"/>
            <a:ext cx="8064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4: Alignment in the Zhongli-2 MYB10 region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20688"/>
            <a:ext cx="9144793" cy="54259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65323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30</Words>
  <Application>Microsoft Office PowerPoint</Application>
  <PresentationFormat>Presentación en pantalla (4:3)</PresentationFormat>
  <Paragraphs>3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6" baseType="lpstr">
      <vt:lpstr>Arial</vt:lpstr>
      <vt:lpstr>Calibri</vt:lpstr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Txosse Aranzana Civit</dc:creator>
  <cp:lastModifiedBy>Txosse Aranzana Civit</cp:lastModifiedBy>
  <cp:revision>6</cp:revision>
  <dcterms:created xsi:type="dcterms:W3CDTF">2021-09-01T14:55:02Z</dcterms:created>
  <dcterms:modified xsi:type="dcterms:W3CDTF">2022-01-24T16:52:27Z</dcterms:modified>
</cp:coreProperties>
</file>